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EE788-585D-414D-8853-574F489E37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D254D-BF6F-45CB-8C35-18E3711518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FDF26-D3C0-431B-A613-BD91817D35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E93B8-76DE-40CD-BADC-4DA4506BD4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12A0D-5E5E-4AF2-8D7D-4E8541492F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E877D-4189-4CD8-9F0D-9E334796D5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EE3F2-14DF-4237-A849-894AB1CFB8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0B5FD-BC4A-4B27-95D4-F4919F063D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501BE-35D4-4789-B1C4-34DFA4E5D4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20456-105C-4F85-9B08-822D10D08F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52A48-83D3-4E99-A2A4-0102CFE9F9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ADD0C-2406-4AAE-AB1A-8B872DE494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3B19AD-BC89-4318-A12B-F5F574F72B4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43080" y="366840"/>
            <a:ext cx="617220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Additional Figure 4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889280" y="7580160"/>
            <a:ext cx="183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28600" y="2316240"/>
          <a:ext cx="3352680" cy="1341360"/>
        </p:xfrm>
        <a:graphic>
          <a:graphicData uri="http://schemas.openxmlformats.org/drawingml/2006/table">
            <a:tbl>
              <a:tblPr/>
              <a:tblGrid>
                <a:gridCol w="838080"/>
                <a:gridCol w="838440"/>
                <a:gridCol w="836640"/>
                <a:gridCol w="839520"/>
              </a:tblGrid>
              <a:tr h="3650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.2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.9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0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.2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.1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1 ORF2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5.9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.1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%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230040" y="1676520"/>
            <a:ext cx="468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2271" t="0" r="5379" b="50600"/>
          <a:stretch/>
        </p:blipFill>
        <p:spPr>
          <a:xfrm>
            <a:off x="1085760" y="1106640"/>
            <a:ext cx="5715000" cy="8019720"/>
          </a:xfrm>
          <a:prstGeom prst="rect">
            <a:avLst/>
          </a:prstGeom>
          <a:ln w="0">
            <a:noFill/>
          </a:ln>
        </p:spPr>
      </p:pic>
      <p:grpSp>
        <p:nvGrpSpPr>
          <p:cNvPr id="46" name=""/>
          <p:cNvGrpSpPr/>
          <p:nvPr/>
        </p:nvGrpSpPr>
        <p:grpSpPr>
          <a:xfrm>
            <a:off x="914400" y="1015920"/>
            <a:ext cx="250920" cy="7976520"/>
            <a:chOff x="914400" y="1015920"/>
            <a:chExt cx="250920" cy="7976520"/>
          </a:xfrm>
        </p:grpSpPr>
        <p:sp>
          <p:nvSpPr>
            <p:cNvPr id="47" name=""/>
            <p:cNvSpPr/>
            <p:nvPr/>
          </p:nvSpPr>
          <p:spPr>
            <a:xfrm>
              <a:off x="914400" y="66031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914400" y="72126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914400" y="782208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914400" y="853344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914400" y="599364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914400" y="53838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914400" y="47743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914400" y="416484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14400" y="355536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14400" y="29437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14400" y="223488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14400" y="16254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914400" y="10159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230040" y="1143000"/>
            <a:ext cx="468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3080" y="-304920"/>
            <a:ext cx="6172200" cy="152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"/>
          <p:cNvGrpSpPr/>
          <p:nvPr/>
        </p:nvGrpSpPr>
        <p:grpSpPr>
          <a:xfrm>
            <a:off x="1028880" y="654120"/>
            <a:ext cx="5829120" cy="8338680"/>
            <a:chOff x="1028880" y="654120"/>
            <a:chExt cx="5829120" cy="8338680"/>
          </a:xfrm>
        </p:grpSpPr>
        <p:pic>
          <p:nvPicPr>
            <p:cNvPr id="63" name="" descr=""/>
            <p:cNvPicPr/>
            <p:nvPr/>
          </p:nvPicPr>
          <p:blipFill>
            <a:blip r:embed="rId1"/>
            <a:srcRect l="1513" t="49238" r="5379" b="0"/>
            <a:stretch/>
          </p:blipFill>
          <p:spPr>
            <a:xfrm>
              <a:off x="1028880" y="654120"/>
              <a:ext cx="5829120" cy="833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"/>
            <p:cNvSpPr/>
            <p:nvPr/>
          </p:nvSpPr>
          <p:spPr>
            <a:xfrm>
              <a:off x="5372280" y="8330400"/>
              <a:ext cx="1485720" cy="507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914400" y="711360"/>
            <a:ext cx="250920" cy="8076240"/>
            <a:chOff x="914400" y="711360"/>
            <a:chExt cx="250920" cy="8076240"/>
          </a:xfrm>
        </p:grpSpPr>
        <p:sp>
          <p:nvSpPr>
            <p:cNvPr id="66" name=""/>
            <p:cNvSpPr/>
            <p:nvPr/>
          </p:nvSpPr>
          <p:spPr>
            <a:xfrm>
              <a:off x="914400" y="640044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914400" y="70081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914400" y="761976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914400" y="83286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914400" y="568908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914400" y="50796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914400" y="44701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914400" y="386028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914400" y="325080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914400" y="263916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914400" y="193032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914400" y="132084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914400" y="711360"/>
              <a:ext cx="250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26T22:02:08Z</dcterms:created>
  <dc:creator>Student Computer</dc:creator>
  <dc:description/>
  <dc:language>en-US</dc:language>
  <cp:lastModifiedBy>Preferred Customer</cp:lastModifiedBy>
  <dcterms:modified xsi:type="dcterms:W3CDTF">2009-09-03T00:26:39Z</dcterms:modified>
  <cp:revision>12</cp:revision>
  <dc:subject/>
  <dc:title>Slide 1</dc:title>
</cp:coreProperties>
</file>